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2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150" d="100"/>
          <a:sy n="150" d="100"/>
        </p:scale>
        <p:origin x="1260" y="1368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7319" y="4499992"/>
            <a:ext cx="7315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4.</a:t>
            </a:r>
            <a:r>
              <a:rPr lang="en-C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Phosphorylation of Ser103 does not affect phosphorylation of other ERF8 residues </a:t>
            </a:r>
            <a:r>
              <a:rPr lang="en-CA" sz="12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MPK11 phosphorylation assays were performed as in Figure 4. WT or mutant (Mu) GST-ERF8 was used in assays as indicated above autoradiogram. Alanine (A) or aspartic acid (D) substitutions were used for </a:t>
            </a:r>
            <a:r>
              <a:rPr lang="en-CA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homimetic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CA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-dead analogs, respectively, at sites 1 (S93), 2 (S103), 3 (T111), or 4 (S71). No difference was observed between S103A (2A) and S103D (2D) mutants, suggesting that the phosphorylation status of S103 does not affect subsequent phosphorylation of additional residues of ERF8.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 descr="C:\Users\Tom\Documents\structure-function\ERF8 MPK stuff\Jan 14.14 32P autorad MPK11 zoom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85" t="31520" r="16032" b="46198"/>
          <a:stretch/>
        </p:blipFill>
        <p:spPr bwMode="auto">
          <a:xfrm>
            <a:off x="2296319" y="3131840"/>
            <a:ext cx="3293762" cy="925354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435997" y="2606711"/>
            <a:ext cx="6317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MPK1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435997" y="2329712"/>
            <a:ext cx="1088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CA-MKK6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35996" y="2927812"/>
            <a:ext cx="69760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ERF8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270920" y="2837713"/>
            <a:ext cx="3857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 +       +        +         +        +         +        +         +       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96320" y="2609113"/>
            <a:ext cx="3857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 -       +        +         +        +         +        +         +       +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96319" y="2340581"/>
            <a:ext cx="3857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+       +        +         +        +         +        +         +       +</a:t>
            </a:r>
          </a:p>
        </p:txBody>
      </p:sp>
      <p:sp>
        <p:nvSpPr>
          <p:cNvPr id="11" name="TextBox 10"/>
          <p:cNvSpPr txBox="1"/>
          <p:nvPr/>
        </p:nvSpPr>
        <p:spPr>
          <a:xfrm rot="18900000">
            <a:off x="2945365" y="1972036"/>
            <a:ext cx="723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71A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900000">
            <a:off x="3220338" y="1719912"/>
            <a:ext cx="1447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71A/T111A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900000">
            <a:off x="3630501" y="1707817"/>
            <a:ext cx="15956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71A/T111A/S93A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8900000">
            <a:off x="4417171" y="1901471"/>
            <a:ext cx="9234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03A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8900000">
            <a:off x="2242778" y="1983305"/>
            <a:ext cx="723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" name="TextBox 15"/>
          <p:cNvSpPr txBox="1"/>
          <p:nvPr/>
        </p:nvSpPr>
        <p:spPr>
          <a:xfrm rot="18900000">
            <a:off x="2602873" y="1972036"/>
            <a:ext cx="723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" name="TextBox 17"/>
          <p:cNvSpPr txBox="1"/>
          <p:nvPr/>
        </p:nvSpPr>
        <p:spPr>
          <a:xfrm rot="18900000">
            <a:off x="4778005" y="1972036"/>
            <a:ext cx="723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03D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900000">
            <a:off x="5149067" y="1974733"/>
            <a:ext cx="723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111A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Isosceles Triangle 19"/>
          <p:cNvSpPr/>
          <p:nvPr/>
        </p:nvSpPr>
        <p:spPr>
          <a:xfrm rot="5400000">
            <a:off x="2176118" y="3641235"/>
            <a:ext cx="72000" cy="72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900000">
            <a:off x="3930019" y="1608289"/>
            <a:ext cx="18806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</a:t>
            </a:r>
            <a:r>
              <a:rPr lang="en-CA" sz="105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d</a:t>
            </a:r>
            <a:r>
              <a:rPr lang="en-CA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4235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3</TotalTime>
  <Words>160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5</cp:revision>
  <dcterms:created xsi:type="dcterms:W3CDTF">2016-09-27T17:34:00Z</dcterms:created>
  <dcterms:modified xsi:type="dcterms:W3CDTF">2018-08-22T14:23:31Z</dcterms:modified>
</cp:coreProperties>
</file>